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9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600"/>
    <a:srgbClr val="205968"/>
    <a:srgbClr val="93CDDE"/>
    <a:srgbClr val="C05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45" autoAdjust="0"/>
    <p:restoredTop sz="97356" autoAdjust="0"/>
  </p:normalViewPr>
  <p:slideViewPr>
    <p:cSldViewPr snapToGrid="0" snapToObjects="1">
      <p:cViewPr>
        <p:scale>
          <a:sx n="126" d="100"/>
          <a:sy n="126" d="100"/>
        </p:scale>
        <p:origin x="4904" y="-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4253F3-D605-0246-B8B7-BCDA9F07A5E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11DED0-0DFD-104F-B8C6-2EAFE995ED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932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11DED0-0DFD-104F-B8C6-2EAFE995ED9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4922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83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573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068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561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014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17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66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642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02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937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13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02B76-BB57-CE49-8B2A-9F2616F44AF9}" type="datetimeFigureOut">
              <a:rPr lang="en-US" smtClean="0"/>
              <a:t>5/1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3860D-6C44-6048-B73A-318D67CA29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147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BEDB204-F929-008F-30A4-03F17126BE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908" y="7131973"/>
            <a:ext cx="4851400" cy="584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868614B-4ADA-E7B7-0201-B97CA2DBBA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1908" y="3632270"/>
            <a:ext cx="5949950" cy="15684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951D289-D5FB-4BB0-BC9B-83144FE1CC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909" y="2164734"/>
            <a:ext cx="5949950" cy="1320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067A6F8-F7B0-397B-1BF5-8C1C018D5C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1908" y="5373952"/>
            <a:ext cx="4851400" cy="5842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22EDE3E-5C99-8FF7-7DE1-6CFD301189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2289" y="6123095"/>
            <a:ext cx="4851400" cy="76835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0E96C79-3E53-625A-1510-8979E902A8E4}"/>
              </a:ext>
            </a:extLst>
          </p:cNvPr>
          <p:cNvSpPr txBox="1"/>
          <p:nvPr/>
        </p:nvSpPr>
        <p:spPr>
          <a:xfrm>
            <a:off x="9963" y="21464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7A0F5B-37FF-6714-6156-D33AC5098B6D}"/>
              </a:ext>
            </a:extLst>
          </p:cNvPr>
          <p:cNvSpPr txBox="1"/>
          <p:nvPr/>
        </p:nvSpPr>
        <p:spPr>
          <a:xfrm>
            <a:off x="84268" y="20786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37B73F-E888-7080-C956-F98666E41DE5}"/>
              </a:ext>
            </a:extLst>
          </p:cNvPr>
          <p:cNvSpPr txBox="1"/>
          <p:nvPr/>
        </p:nvSpPr>
        <p:spPr>
          <a:xfrm>
            <a:off x="95488" y="3592414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872AB9B-74CD-3462-988D-BD53C19F21A0}"/>
              </a:ext>
            </a:extLst>
          </p:cNvPr>
          <p:cNvSpPr txBox="1"/>
          <p:nvPr/>
        </p:nvSpPr>
        <p:spPr>
          <a:xfrm>
            <a:off x="74271" y="5297247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6263898-5060-B1EC-CA06-FCB5F3E352F5}"/>
              </a:ext>
            </a:extLst>
          </p:cNvPr>
          <p:cNvSpPr txBox="1"/>
          <p:nvPr/>
        </p:nvSpPr>
        <p:spPr>
          <a:xfrm>
            <a:off x="62104" y="603435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93A7573-31D1-F12C-BFE0-C5DC5DEF5296}"/>
              </a:ext>
            </a:extLst>
          </p:cNvPr>
          <p:cNvSpPr txBox="1"/>
          <p:nvPr/>
        </p:nvSpPr>
        <p:spPr>
          <a:xfrm>
            <a:off x="94266" y="7044479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BE9C39B-70F8-F781-BD89-874684700A0D}"/>
              </a:ext>
            </a:extLst>
          </p:cNvPr>
          <p:cNvGrpSpPr/>
          <p:nvPr/>
        </p:nvGrpSpPr>
        <p:grpSpPr>
          <a:xfrm>
            <a:off x="385909" y="199036"/>
            <a:ext cx="2720259" cy="1840548"/>
            <a:chOff x="385909" y="199036"/>
            <a:chExt cx="2869903" cy="217800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F2056B6-F8B3-FBB1-A3F5-1A85F1776C2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5909" y="199036"/>
              <a:ext cx="2869903" cy="2178008"/>
            </a:xfrm>
            <a:prstGeom prst="rect">
              <a:avLst/>
            </a:prstGeom>
          </p:spPr>
        </p:pic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51BC98BB-70BA-2F2B-4F1B-6557FC62202A}"/>
                </a:ext>
              </a:extLst>
            </p:cNvPr>
            <p:cNvSpPr/>
            <p:nvPr/>
          </p:nvSpPr>
          <p:spPr>
            <a:xfrm>
              <a:off x="1933662" y="1296551"/>
              <a:ext cx="1119931" cy="4907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ln>
                  <a:solidFill>
                    <a:schemeClr val="bg1"/>
                  </a:solidFill>
                </a:ln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170A083-B9BF-5934-F64A-1F74126D387F}"/>
                </a:ext>
              </a:extLst>
            </p:cNvPr>
            <p:cNvSpPr txBox="1"/>
            <p:nvPr/>
          </p:nvSpPr>
          <p:spPr>
            <a:xfrm>
              <a:off x="1869283" y="1365188"/>
              <a:ext cx="5084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/>
                <a:t>Chow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B19E286-FA95-D0A7-11F7-7DC193F4FEBF}"/>
                </a:ext>
              </a:extLst>
            </p:cNvPr>
            <p:cNvSpPr txBox="1"/>
            <p:nvPr/>
          </p:nvSpPr>
          <p:spPr>
            <a:xfrm>
              <a:off x="1869282" y="1566096"/>
              <a:ext cx="5725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100" dirty="0" err="1"/>
                <a:t>ChowS</a:t>
              </a:r>
              <a:endParaRPr lang="en-AU" sz="1100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670810E-5A26-2121-B840-6E18DCF780DD}"/>
              </a:ext>
            </a:extLst>
          </p:cNvPr>
          <p:cNvSpPr txBox="1"/>
          <p:nvPr/>
        </p:nvSpPr>
        <p:spPr>
          <a:xfrm>
            <a:off x="161050" y="7796117"/>
            <a:ext cx="6363858" cy="20928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:</a:t>
            </a:r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 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odyweight curve of female WT mice</a:t>
            </a:r>
            <a:r>
              <a:rPr lang="en-AU" sz="1000" kern="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 a chow or a chow combined with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ress paradigm for 25 days. Data means ± SEM, 7-9 mice per group. (B) Absolute Weight of dissected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ite adipose depots between male mice on a 14-day Chow or </a:t>
            </a:r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owS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aradigm: inguinal fat (</a:t>
            </a:r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pididymal (e), mesenteric (m), perirenal fat (r) and summed total fat mass </a:t>
            </a:r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BAT. 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means ± SEM,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2 mice per group. (C) Fat mass weight of white adipose depots normalized to body weight of  male mice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 a 14 days Chow or </a:t>
            </a:r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owS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aradigm: inguinal fat (</a:t>
            </a:r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epididymal (e), mesenteric (m), and perirenal fat (r),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T and sum of total fat mass (Total). Data are means ± SEM, 12 mice per group. (D) Serum insulin levels of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le mice on a 14-day Chow and </a:t>
            </a:r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owS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aradigm at the end of treatment. Data are means ± SEM, 8 mice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 group. (E) Quantification of Fos expression in the </a:t>
            </a:r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A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male mice 14 days on either a Chow or a </a:t>
            </a:r>
          </a:p>
          <a:p>
            <a:r>
              <a:rPr lang="en-US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owS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aradigm. Data are means ± SEM, n = 5 mice per group. (F) </a:t>
            </a:r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uantification of GFP positive neurons </a:t>
            </a:r>
          </a:p>
          <a:p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the </a:t>
            </a:r>
            <a:r>
              <a:rPr lang="en-AU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A</a:t>
            </a:r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lang="en-AU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py</a:t>
            </a:r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FP reporter mice under a 14day Chow or </a:t>
            </a:r>
            <a:r>
              <a:rPr lang="en-AU" sz="1000" kern="100" dirty="0" err="1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owS</a:t>
            </a:r>
            <a:r>
              <a:rPr lang="en-AU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aradigm. </a:t>
            </a:r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means ± SEM, </a:t>
            </a:r>
          </a:p>
          <a:p>
            <a:r>
              <a:rPr lang="en-US" sz="1000" kern="100" dirty="0">
                <a:solidFill>
                  <a:srgbClr val="00003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 mice per group.</a:t>
            </a:r>
            <a:endParaRPr lang="en-AU" sz="10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6052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82</TotalTime>
  <Words>276</Words>
  <Application>Microsoft Macintosh PowerPoint</Application>
  <PresentationFormat>A4 Paper (210x297 mm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y Ip</dc:creator>
  <cp:lastModifiedBy>Herbert Herzog</cp:lastModifiedBy>
  <cp:revision>226</cp:revision>
  <cp:lastPrinted>2022-05-24T01:51:32Z</cp:lastPrinted>
  <dcterms:modified xsi:type="dcterms:W3CDTF">2025-05-19T04:47:32Z</dcterms:modified>
</cp:coreProperties>
</file>